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4"/>
  </p:notesMasterIdLst>
  <p:sldIdLst>
    <p:sldId id="323" r:id="rId2"/>
    <p:sldId id="324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99"/>
    <a:srgbClr val="996633"/>
    <a:srgbClr val="0000FF"/>
    <a:srgbClr val="E6E6E6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 autoAdjust="0"/>
    <p:restoredTop sz="94150" autoAdjust="0"/>
  </p:normalViewPr>
  <p:slideViewPr>
    <p:cSldViewPr snapToGrid="0">
      <p:cViewPr varScale="1">
        <p:scale>
          <a:sx n="90" d="100"/>
          <a:sy n="90" d="100"/>
        </p:scale>
        <p:origin x="2456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4F2F90B-FAEE-43A6-911B-A463AC77073A}" type="datetimeFigureOut">
              <a:rPr lang="en-US" smtClean="0"/>
              <a:t>6/8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0CF592E-0549-47A5-B954-7BE64C9A626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31503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0CF592E-0549-47A5-B954-7BE64C9A626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40265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0CF592E-0549-47A5-B954-7BE64C9A6260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09293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B7E80-15FC-4BDB-932E-58CC48BD2C17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0DFCE-354A-4D25-9804-F4F948E3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80907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B7E80-15FC-4BDB-932E-58CC48BD2C17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0DFCE-354A-4D25-9804-F4F948E3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1096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B7E80-15FC-4BDB-932E-58CC48BD2C17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0DFCE-354A-4D25-9804-F4F948E3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6426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B7E80-15FC-4BDB-932E-58CC48BD2C17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0DFCE-354A-4D25-9804-F4F948E3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635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B7E80-15FC-4BDB-932E-58CC48BD2C17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0DFCE-354A-4D25-9804-F4F948E3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30753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B7E80-15FC-4BDB-932E-58CC48BD2C17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0DFCE-354A-4D25-9804-F4F948E3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385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B7E80-15FC-4BDB-932E-58CC48BD2C17}" type="datetimeFigureOut">
              <a:rPr lang="en-US" smtClean="0"/>
              <a:t>6/8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0DFCE-354A-4D25-9804-F4F948E3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9485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B7E80-15FC-4BDB-932E-58CC48BD2C17}" type="datetimeFigureOut">
              <a:rPr lang="en-US" smtClean="0"/>
              <a:t>6/8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0DFCE-354A-4D25-9804-F4F948E3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0913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B7E80-15FC-4BDB-932E-58CC48BD2C17}" type="datetimeFigureOut">
              <a:rPr lang="en-US" smtClean="0"/>
              <a:t>6/8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0DFCE-354A-4D25-9804-F4F948E3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519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B7E80-15FC-4BDB-932E-58CC48BD2C17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0DFCE-354A-4D25-9804-F4F948E3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045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5B7E80-15FC-4BDB-932E-58CC48BD2C17}" type="datetimeFigureOut">
              <a:rPr lang="en-US" smtClean="0"/>
              <a:t>6/8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0DFCE-354A-4D25-9804-F4F948E3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715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5B7E80-15FC-4BDB-932E-58CC48BD2C17}" type="datetimeFigureOut">
              <a:rPr lang="en-US" smtClean="0"/>
              <a:t>6/8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20DFCE-354A-4D25-9804-F4F948E3DA7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6071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E57522-1E26-E842-A820-2DEEA18A6E83}"/>
              </a:ext>
            </a:extLst>
          </p:cNvPr>
          <p:cNvSpPr txBox="1">
            <a:spLocks/>
          </p:cNvSpPr>
          <p:nvPr/>
        </p:nvSpPr>
        <p:spPr>
          <a:xfrm>
            <a:off x="16153" y="182678"/>
            <a:ext cx="6720226" cy="723989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LSK frequencies in male and female BM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5C3EBF5-6E40-C04D-886E-5DB9ECD829E1}"/>
              </a:ext>
            </a:extLst>
          </p:cNvPr>
          <p:cNvSpPr txBox="1"/>
          <p:nvPr/>
        </p:nvSpPr>
        <p:spPr>
          <a:xfrm>
            <a:off x="146430" y="4248834"/>
            <a:ext cx="656513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1: 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Frequencies of lineage-cKit+Sca1+ (LSK) in male and female mice. N=8 mice/arm. 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3E5731F-5CC6-4E47-816C-1523C73203E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2542" b="56305"/>
          <a:stretch/>
        </p:blipFill>
        <p:spPr>
          <a:xfrm>
            <a:off x="2447089" y="2072881"/>
            <a:ext cx="708823" cy="593769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5AF3FF9E-43D2-1947-99A0-2C5F7AFE41F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8349" y="1290674"/>
            <a:ext cx="2387563" cy="19803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657614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E57522-1E26-E842-A820-2DEEA18A6E83}"/>
              </a:ext>
            </a:extLst>
          </p:cNvPr>
          <p:cNvSpPr txBox="1">
            <a:spLocks/>
          </p:cNvSpPr>
          <p:nvPr/>
        </p:nvSpPr>
        <p:spPr>
          <a:xfrm>
            <a:off x="16153" y="182678"/>
            <a:ext cx="6720226" cy="723989"/>
          </a:xfrm>
          <a:prstGeom prst="rect">
            <a:avLst/>
          </a:prstGeom>
        </p:spPr>
        <p:txBody>
          <a:bodyPr>
            <a:no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 Testosterone supplementation to BM cultures does not impact the HSPC population.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68BDF47-CE64-8A48-9297-0386B74B01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153" y="1071561"/>
            <a:ext cx="2930526" cy="281781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26EC97AA-B2E6-E04B-8ECC-4D76A9453CD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76266" y="1071560"/>
            <a:ext cx="2981166" cy="281781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5C3EBF5-6E40-C04D-886E-5DB9ECD829E1}"/>
              </a:ext>
            </a:extLst>
          </p:cNvPr>
          <p:cNvSpPr txBox="1"/>
          <p:nvPr/>
        </p:nvSpPr>
        <p:spPr>
          <a:xfrm>
            <a:off x="146430" y="4248834"/>
            <a:ext cx="656513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2: 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Frequencies of lineage-cKit+Sca1+ (LSK) and LSK CD150+CD48- (LT-HSC) following 5 days of total male and female BM cultured with the indicated doses of Testosterone (T).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23E5731F-5CC6-4E47-816C-1523C73203E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2542" b="56305"/>
          <a:stretch/>
        </p:blipFill>
        <p:spPr>
          <a:xfrm>
            <a:off x="6094059" y="1886698"/>
            <a:ext cx="708823" cy="59376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511668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7852</TotalTime>
  <Words>99</Words>
  <Application>Microsoft Macintosh PowerPoint</Application>
  <PresentationFormat>On-screen Show (4:3)</PresentationFormat>
  <Paragraphs>6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NS10</dc:creator>
  <cp:lastModifiedBy>Amar Desai</cp:lastModifiedBy>
  <cp:revision>483</cp:revision>
  <cp:lastPrinted>2022-06-02T17:37:01Z</cp:lastPrinted>
  <dcterms:created xsi:type="dcterms:W3CDTF">2019-01-09T15:17:30Z</dcterms:created>
  <dcterms:modified xsi:type="dcterms:W3CDTF">2022-06-08T14:31:59Z</dcterms:modified>
</cp:coreProperties>
</file>